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6" d="100"/>
          <a:sy n="86" d="100"/>
        </p:scale>
        <p:origin x="331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1C794-9D7A-4FDC-98EB-741B0474EAD6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544A0-0608-4CA1-993B-CADF2184BAD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08528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1C794-9D7A-4FDC-98EB-741B0474EAD6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544A0-0608-4CA1-993B-CADF2184BAD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2250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1C794-9D7A-4FDC-98EB-741B0474EAD6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544A0-0608-4CA1-993B-CADF2184BAD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44768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1C794-9D7A-4FDC-98EB-741B0474EAD6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544A0-0608-4CA1-993B-CADF2184BAD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41118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1C794-9D7A-4FDC-98EB-741B0474EAD6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544A0-0608-4CA1-993B-CADF2184BAD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21122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1C794-9D7A-4FDC-98EB-741B0474EAD6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544A0-0608-4CA1-993B-CADF2184BAD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39930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1C794-9D7A-4FDC-98EB-741B0474EAD6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544A0-0608-4CA1-993B-CADF2184BAD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43877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1C794-9D7A-4FDC-98EB-741B0474EAD6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544A0-0608-4CA1-993B-CADF2184BAD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09594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1C794-9D7A-4FDC-98EB-741B0474EAD6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544A0-0608-4CA1-993B-CADF2184BAD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69903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1C794-9D7A-4FDC-98EB-741B0474EAD6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544A0-0608-4CA1-993B-CADF2184BAD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264038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1C794-9D7A-4FDC-98EB-741B0474EAD6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544A0-0608-4CA1-993B-CADF2184BAD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15645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1C794-9D7A-4FDC-98EB-741B0474EAD6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544A0-0608-4CA1-993B-CADF2184BAD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75977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Csoportba foglalás 3"/>
          <p:cNvGrpSpPr/>
          <p:nvPr/>
        </p:nvGrpSpPr>
        <p:grpSpPr>
          <a:xfrm>
            <a:off x="2009103" y="940158"/>
            <a:ext cx="7653338" cy="4391697"/>
            <a:chOff x="451680" y="2901786"/>
            <a:chExt cx="5838881" cy="3426979"/>
          </a:xfrm>
        </p:grpSpPr>
        <p:grpSp>
          <p:nvGrpSpPr>
            <p:cNvPr id="5" name="Csoportba foglalás 4"/>
            <p:cNvGrpSpPr/>
            <p:nvPr/>
          </p:nvGrpSpPr>
          <p:grpSpPr>
            <a:xfrm>
              <a:off x="451680" y="3190460"/>
              <a:ext cx="5760277" cy="3138305"/>
              <a:chOff x="-11659" y="147766"/>
              <a:chExt cx="12165386" cy="6445525"/>
            </a:xfrm>
          </p:grpSpPr>
          <p:grpSp>
            <p:nvGrpSpPr>
              <p:cNvPr id="8" name="Csoportba foglalás 7"/>
              <p:cNvGrpSpPr/>
              <p:nvPr/>
            </p:nvGrpSpPr>
            <p:grpSpPr>
              <a:xfrm>
                <a:off x="-11659" y="3371278"/>
                <a:ext cx="12165386" cy="3222013"/>
                <a:chOff x="-11659" y="3371278"/>
                <a:chExt cx="12165386" cy="3222013"/>
              </a:xfrm>
            </p:grpSpPr>
            <p:pic>
              <p:nvPicPr>
                <p:cNvPr id="13" name="Kép 12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7127" t="53" r="34793" b="682"/>
                <a:stretch/>
              </p:blipFill>
              <p:spPr>
                <a:xfrm rot="5400000">
                  <a:off x="-82544" y="3442163"/>
                  <a:ext cx="3222000" cy="3080230"/>
                </a:xfrm>
                <a:prstGeom prst="rect">
                  <a:avLst/>
                </a:prstGeom>
              </p:spPr>
            </p:pic>
            <p:pic>
              <p:nvPicPr>
                <p:cNvPr id="14" name="Kép 13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202" t="30" r="31044" b="707"/>
                <a:stretch/>
              </p:blipFill>
              <p:spPr>
                <a:xfrm rot="5400000">
                  <a:off x="2960069" y="3469188"/>
                  <a:ext cx="3222000" cy="3026189"/>
                </a:xfrm>
                <a:prstGeom prst="rect">
                  <a:avLst/>
                </a:prstGeom>
              </p:spPr>
            </p:pic>
            <p:pic>
              <p:nvPicPr>
                <p:cNvPr id="15" name="Kép 14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9744" t="657" r="32284" b="-581"/>
                <a:stretch/>
              </p:blipFill>
              <p:spPr>
                <a:xfrm rot="5400000">
                  <a:off x="5963995" y="3434291"/>
                  <a:ext cx="3222000" cy="3095999"/>
                </a:xfrm>
                <a:prstGeom prst="rect">
                  <a:avLst/>
                </a:prstGeom>
              </p:spPr>
            </p:pic>
            <p:pic>
              <p:nvPicPr>
                <p:cNvPr id="16" name="Tartalom helye 14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503" t="324" r="31603" b="1703"/>
                <a:stretch/>
              </p:blipFill>
              <p:spPr>
                <a:xfrm rot="5400000">
                  <a:off x="8990046" y="3429603"/>
                  <a:ext cx="3222000" cy="3105362"/>
                </a:xfrm>
                <a:prstGeom prst="rect">
                  <a:avLst/>
                </a:prstGeom>
              </p:spPr>
            </p:pic>
          </p:grpSp>
          <p:pic>
            <p:nvPicPr>
              <p:cNvPr id="9" name="Kép 8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130" t="1373" r="32877" b="4057"/>
              <a:stretch/>
            </p:blipFill>
            <p:spPr>
              <a:xfrm rot="16200000">
                <a:off x="9045688" y="263230"/>
                <a:ext cx="3223493" cy="2992585"/>
              </a:xfrm>
              <a:prstGeom prst="rect">
                <a:avLst/>
              </a:prstGeom>
            </p:spPr>
          </p:pic>
          <p:pic>
            <p:nvPicPr>
              <p:cNvPr id="10" name="Kép 9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357" t="1637" r="30909" b="557"/>
              <a:stretch/>
            </p:blipFill>
            <p:spPr>
              <a:xfrm rot="16200000">
                <a:off x="5994851" y="203485"/>
                <a:ext cx="3222000" cy="3110582"/>
              </a:xfrm>
              <a:prstGeom prst="rect">
                <a:avLst/>
              </a:prstGeom>
            </p:spPr>
          </p:pic>
          <p:pic>
            <p:nvPicPr>
              <p:cNvPr id="11" name="Kép 10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020" t="379" r="30842" b="-1102"/>
              <a:stretch/>
            </p:blipFill>
            <p:spPr>
              <a:xfrm rot="16200000">
                <a:off x="2969571" y="170790"/>
                <a:ext cx="3222000" cy="3175972"/>
              </a:xfrm>
              <a:prstGeom prst="rect">
                <a:avLst/>
              </a:prstGeom>
            </p:spPr>
          </p:pic>
          <p:pic>
            <p:nvPicPr>
              <p:cNvPr id="12" name="Kép 11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741" t="2549" r="32525" b="-1228"/>
              <a:stretch/>
            </p:blipFill>
            <p:spPr>
              <a:xfrm rot="16200000">
                <a:off x="-47615" y="183723"/>
                <a:ext cx="3222000" cy="3150086"/>
              </a:xfrm>
              <a:prstGeom prst="rect">
                <a:avLst/>
              </a:prstGeom>
            </p:spPr>
          </p:pic>
        </p:grpSp>
        <p:sp>
          <p:nvSpPr>
            <p:cNvPr id="6" name="Szövegdoboz 5"/>
            <p:cNvSpPr txBox="1"/>
            <p:nvPr/>
          </p:nvSpPr>
          <p:spPr>
            <a:xfrm>
              <a:off x="840558" y="2901786"/>
              <a:ext cx="5450003" cy="2641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600" b="1" dirty="0"/>
                <a:t>     0 sec.	                      20 sec.	                          40 sec.	                          60 sec.</a:t>
              </a:r>
            </a:p>
          </p:txBody>
        </p:sp>
      </p:grpSp>
      <p:sp>
        <p:nvSpPr>
          <p:cNvPr id="17" name="Szövegdoboz 16"/>
          <p:cNvSpPr txBox="1"/>
          <p:nvPr/>
        </p:nvSpPr>
        <p:spPr>
          <a:xfrm>
            <a:off x="1741507" y="2146019"/>
            <a:ext cx="296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600" b="1" dirty="0"/>
              <a:t>A</a:t>
            </a:r>
          </a:p>
        </p:txBody>
      </p:sp>
      <p:sp>
        <p:nvSpPr>
          <p:cNvPr id="18" name="Szövegdoboz 17"/>
          <p:cNvSpPr txBox="1"/>
          <p:nvPr/>
        </p:nvSpPr>
        <p:spPr>
          <a:xfrm>
            <a:off x="1763252" y="4156424"/>
            <a:ext cx="296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600" b="1" dirty="0"/>
              <a:t>B</a:t>
            </a:r>
          </a:p>
        </p:txBody>
      </p:sp>
      <p:sp>
        <p:nvSpPr>
          <p:cNvPr id="19" name="Szövegdoboz 18"/>
          <p:cNvSpPr txBox="1"/>
          <p:nvPr/>
        </p:nvSpPr>
        <p:spPr>
          <a:xfrm>
            <a:off x="2009103" y="5460642"/>
            <a:ext cx="766293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Figure S</a:t>
            </a:r>
            <a:r>
              <a:rPr lang="hu-HU" dirty="0"/>
              <a:t>4</a:t>
            </a:r>
            <a:r>
              <a:rPr lang="en-AU" dirty="0"/>
              <a:t>. Colony forming capacity after UV treatment. Wild-type strain (A), </a:t>
            </a:r>
            <a:r>
              <a:rPr lang="en-AU" i="1" dirty="0"/>
              <a:t>lig4</a:t>
            </a:r>
            <a:r>
              <a:rPr lang="en-AU" i="1" dirty="0">
                <a:sym typeface="Symbol" panose="05050102010706020507" pitchFamily="18" charset="2"/>
              </a:rPr>
              <a:t> </a:t>
            </a:r>
            <a:r>
              <a:rPr lang="en-AU" dirty="0">
                <a:sym typeface="Symbol" panose="05050102010706020507" pitchFamily="18" charset="2"/>
              </a:rPr>
              <a:t>mutant strain (334) (B). (0 sec: control agar plates, while the other plates were treated by UV light for 20,40,</a:t>
            </a:r>
            <a:r>
              <a:rPr lang="hu-HU">
                <a:sym typeface="Symbol" panose="05050102010706020507" pitchFamily="18" charset="2"/>
              </a:rPr>
              <a:t> and </a:t>
            </a:r>
            <a:r>
              <a:rPr lang="en-AU">
                <a:sym typeface="Symbol" panose="05050102010706020507" pitchFamily="18" charset="2"/>
              </a:rPr>
              <a:t>60 </a:t>
            </a:r>
            <a:r>
              <a:rPr lang="en-AU" dirty="0">
                <a:sym typeface="Symbol" panose="05050102010706020507" pitchFamily="18" charset="2"/>
              </a:rPr>
              <a:t>sec.)</a:t>
            </a:r>
            <a:endParaRPr lang="en-AU" dirty="0"/>
          </a:p>
          <a:p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7238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70</Words>
  <Application>Microsoft Office PowerPoint</Application>
  <PresentationFormat>Szélesvásznú</PresentationFormat>
  <Paragraphs>4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-bemutató</vt:lpstr>
    </vt:vector>
  </TitlesOfParts>
  <Company>WXPE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-</dc:creator>
  <cp:lastModifiedBy>Gálné dr. Miklós Ida</cp:lastModifiedBy>
  <cp:revision>25</cp:revision>
  <dcterms:created xsi:type="dcterms:W3CDTF">2022-03-30T06:56:52Z</dcterms:created>
  <dcterms:modified xsi:type="dcterms:W3CDTF">2023-04-15T12:22:39Z</dcterms:modified>
</cp:coreProperties>
</file>